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modernComment_100_6AA9D4C9.xml" ContentType="application/vnd.ms-powerpoint.comments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719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5C38D09-36CD-369A-A9F1-CB7333FE7CDA}" name="Anne Vifladt" initials="AV" userId="S::annevi@ntnu.no::b6dddd5d-0eb5-43ec-8417-adf9577e9e2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D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F2D66F-5B90-4D71-9F25-2B077E140D8E}" v="2" dt="2026-01-13T08:33:38.184"/>
    <p1510:client id="{DEB652BC-F729-9F4D-99E5-54B7E42CC022}" v="7" dt="2026-01-13T08:37:03.0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e Vifladt" userId="S::annevi@ntnu.no::b6dddd5d-0eb5-43ec-8417-adf9577e9e27" providerId="AD" clId="Web-{56F2D66F-5B90-4D71-9F25-2B077E140D8E}"/>
    <pc:docChg chg="mod">
      <pc:chgData name="Anne Vifladt" userId="S::annevi@ntnu.no::b6dddd5d-0eb5-43ec-8417-adf9577e9e27" providerId="AD" clId="Web-{56F2D66F-5B90-4D71-9F25-2B077E140D8E}" dt="2026-01-13T08:33:38.184" v="0"/>
      <pc:docMkLst>
        <pc:docMk/>
      </pc:docMkLst>
    </pc:docChg>
  </pc:docChgLst>
  <pc:docChgLst>
    <pc:chgData name="Kjetil Myhr" userId="1aa59199-b73d-4e76-a3ff-d2413d7f082a" providerId="ADAL" clId="{C5621597-8DBC-5C2F-AEC3-3534CBB39661}"/>
    <pc:docChg chg="modSld">
      <pc:chgData name="Kjetil Myhr" userId="1aa59199-b73d-4e76-a3ff-d2413d7f082a" providerId="ADAL" clId="{C5621597-8DBC-5C2F-AEC3-3534CBB39661}" dt="2026-01-13T08:37:03.073" v="41" actId="20577"/>
      <pc:docMkLst>
        <pc:docMk/>
      </pc:docMkLst>
      <pc:sldChg chg="modSp mod modCm">
        <pc:chgData name="Kjetil Myhr" userId="1aa59199-b73d-4e76-a3ff-d2413d7f082a" providerId="ADAL" clId="{C5621597-8DBC-5C2F-AEC3-3534CBB39661}" dt="2026-01-13T08:37:03.073" v="41" actId="20577"/>
        <pc:sldMkLst>
          <pc:docMk/>
          <pc:sldMk cId="1789514953" sldId="256"/>
        </pc:sldMkLst>
        <pc:spChg chg="mod">
          <ac:chgData name="Kjetil Myhr" userId="1aa59199-b73d-4e76-a3ff-d2413d7f082a" providerId="ADAL" clId="{C5621597-8DBC-5C2F-AEC3-3534CBB39661}" dt="2026-01-13T08:36:54.058" v="37" actId="20577"/>
          <ac:spMkLst>
            <pc:docMk/>
            <pc:sldMk cId="1789514953" sldId="256"/>
            <ac:spMk id="14" creationId="{46B428CD-8B7E-EE5D-5FCC-973304B87D2B}"/>
          </ac:spMkLst>
        </pc:spChg>
        <pc:spChg chg="mod">
          <ac:chgData name="Kjetil Myhr" userId="1aa59199-b73d-4e76-a3ff-d2413d7f082a" providerId="ADAL" clId="{C5621597-8DBC-5C2F-AEC3-3534CBB39661}" dt="2026-01-13T08:36:59.156" v="39" actId="20577"/>
          <ac:spMkLst>
            <pc:docMk/>
            <pc:sldMk cId="1789514953" sldId="256"/>
            <ac:spMk id="15" creationId="{7CE3879D-4E3F-8B68-30A3-D6CEFC061A9D}"/>
          </ac:spMkLst>
        </pc:spChg>
        <pc:spChg chg="mod">
          <ac:chgData name="Kjetil Myhr" userId="1aa59199-b73d-4e76-a3ff-d2413d7f082a" providerId="ADAL" clId="{C5621597-8DBC-5C2F-AEC3-3534CBB39661}" dt="2026-01-13T08:37:03.073" v="41" actId="20577"/>
          <ac:spMkLst>
            <pc:docMk/>
            <pc:sldMk cId="1789514953" sldId="256"/>
            <ac:spMk id="19" creationId="{B8BD278F-F00F-1AC9-91AC-AE783472F65E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mod">
              <pc226:chgData name="Kjetil Myhr" userId="1aa59199-b73d-4e76-a3ff-d2413d7f082a" providerId="ADAL" clId="{C5621597-8DBC-5C2F-AEC3-3534CBB39661}" dt="2026-01-13T08:36:54.058" v="37" actId="20577"/>
              <pc2:cmMkLst xmlns:pc2="http://schemas.microsoft.com/office/powerpoint/2019/9/main/command">
                <pc:docMk/>
                <pc:sldMk cId="1789514953" sldId="256"/>
                <pc2:cmMk id="{DF953D86-1F3D-4026-AAD3-B94FC76A03B4}"/>
              </pc2:cmMkLst>
            </pc226:cmChg>
          </p:ext>
        </pc:extLst>
      </pc:sldChg>
    </pc:docChg>
  </pc:docChgLst>
</pc:chgInfo>
</file>

<file path=ppt/comments/modernComment_100_6AA9D4C9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DF953D86-1F3D-4026-AAD3-B94FC76A03B4}" authorId="{E5C38D09-36CD-369A-A9F1-CB7333FE7CDA}" created="2026-01-13T08:33:38.184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1789514953" sldId="256"/>
      <ac:spMk id="14" creationId="{46B428CD-8B7E-EE5D-5FCC-973304B87D2B}"/>
      <ac:txMk cp="13">
        <ac:context len="125" hash="1120279704"/>
      </ac:txMk>
    </ac:txMkLst>
    <p188:pos x="1160584" y="202223"/>
    <p188:txBody>
      <a:bodyPr/>
      <a:lstStyle/>
      <a:p>
        <a:r>
          <a:rPr lang="nb-NO"/>
          <a:t>Skrivefeil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09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408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17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345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28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952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736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383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812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358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679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DE6118-2437-4B30-8E3C-4D2BE6020583}" type="datetimeFigureOut">
              <a:rPr lang="en-US" smtClean="0"/>
              <a:pPr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57DC2-970A-4B3E-BB1C-7A09969E49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656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0" r:id="rId1"/>
    <p:sldLayoutId id="2147483721" r:id="rId2"/>
    <p:sldLayoutId id="2147483722" r:id="rId3"/>
    <p:sldLayoutId id="2147483723" r:id="rId4"/>
    <p:sldLayoutId id="2147483724" r:id="rId5"/>
    <p:sldLayoutId id="2147483725" r:id="rId6"/>
    <p:sldLayoutId id="2147483726" r:id="rId7"/>
    <p:sldLayoutId id="2147483727" r:id="rId8"/>
    <p:sldLayoutId id="2147483728" r:id="rId9"/>
    <p:sldLayoutId id="2147483729" r:id="rId10"/>
    <p:sldLayoutId id="2147483730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microsoft.com/office/2018/10/relationships/comments" Target="../comments/modernComment_100_6AA9D4C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  <a:alpha val="3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ounded Rectangle 40">
            <a:extLst>
              <a:ext uri="{FF2B5EF4-FFF2-40B4-BE49-F238E27FC236}">
                <a16:creationId xmlns:a16="http://schemas.microsoft.com/office/drawing/2014/main" id="{1326A9B7-382A-AAF6-B6F2-16B12E42F47D}"/>
              </a:ext>
            </a:extLst>
          </p:cNvPr>
          <p:cNvSpPr/>
          <p:nvPr/>
        </p:nvSpPr>
        <p:spPr>
          <a:xfrm>
            <a:off x="437467" y="368136"/>
            <a:ext cx="4134533" cy="1218622"/>
          </a:xfrm>
          <a:prstGeom prst="roundRect">
            <a:avLst/>
          </a:prstGeom>
          <a:solidFill>
            <a:schemeClr val="accent2">
              <a:lumMod val="20000"/>
              <a:lumOff val="80000"/>
              <a:alpha val="22848"/>
            </a:schemeClr>
          </a:solidFill>
          <a:ln w="69850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42" name="Rounded Rectangle 41">
            <a:extLst>
              <a:ext uri="{FF2B5EF4-FFF2-40B4-BE49-F238E27FC236}">
                <a16:creationId xmlns:a16="http://schemas.microsoft.com/office/drawing/2014/main" id="{D65496F5-10AC-436D-5633-6E2003282E91}"/>
              </a:ext>
            </a:extLst>
          </p:cNvPr>
          <p:cNvSpPr/>
          <p:nvPr/>
        </p:nvSpPr>
        <p:spPr>
          <a:xfrm>
            <a:off x="403838" y="1978057"/>
            <a:ext cx="4134534" cy="4633367"/>
          </a:xfrm>
          <a:prstGeom prst="roundRect">
            <a:avLst/>
          </a:prstGeom>
          <a:solidFill>
            <a:schemeClr val="accent2">
              <a:lumMod val="20000"/>
              <a:lumOff val="80000"/>
              <a:alpha val="22848"/>
            </a:schemeClr>
          </a:solidFill>
          <a:ln w="69850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40" name="Rounded Rectangle 39">
            <a:extLst>
              <a:ext uri="{FF2B5EF4-FFF2-40B4-BE49-F238E27FC236}">
                <a16:creationId xmlns:a16="http://schemas.microsoft.com/office/drawing/2014/main" id="{BD47CA86-968A-91B0-531E-1AA87A34448D}"/>
              </a:ext>
            </a:extLst>
          </p:cNvPr>
          <p:cNvSpPr/>
          <p:nvPr/>
        </p:nvSpPr>
        <p:spPr>
          <a:xfrm>
            <a:off x="4937580" y="338429"/>
            <a:ext cx="4008228" cy="6291138"/>
          </a:xfrm>
          <a:prstGeom prst="roundRect">
            <a:avLst/>
          </a:prstGeom>
          <a:solidFill>
            <a:schemeClr val="accent2">
              <a:lumMod val="20000"/>
              <a:lumOff val="80000"/>
              <a:alpha val="22848"/>
            </a:schemeClr>
          </a:solidFill>
          <a:ln w="69850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23E0354-DDCA-7D35-BBD7-4E4AB52BF3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02397" y="0"/>
            <a:ext cx="3902264" cy="1360915"/>
          </a:xfrm>
        </p:spPr>
        <p:txBody>
          <a:bodyPr>
            <a:noAutofit/>
          </a:bodyPr>
          <a:lstStyle/>
          <a:p>
            <a:r>
              <a:rPr lang="nb-NO" sz="2400" b="1">
                <a:latin typeface="+mn-lt"/>
              </a:rPr>
              <a:t>Medication administration in the ambulance service</a:t>
            </a:r>
            <a:endParaRPr lang="en-NO" sz="2400" b="1">
              <a:latin typeface="+mn-lt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EFEBE7-4B7F-CFD3-3AF4-1FEBD63D08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353503" y="1136619"/>
            <a:ext cx="1259891" cy="393138"/>
          </a:xfrm>
        </p:spPr>
        <p:txBody>
          <a:bodyPr>
            <a:noAutofit/>
          </a:bodyPr>
          <a:lstStyle/>
          <a:p>
            <a:r>
              <a:rPr lang="en-NO" sz="2000" b="1"/>
              <a:t>Person 1</a:t>
            </a:r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65FDF9AB-4C15-3777-E148-B6FDD4A068AE}"/>
              </a:ext>
            </a:extLst>
          </p:cNvPr>
          <p:cNvSpPr txBox="1">
            <a:spLocks/>
          </p:cNvSpPr>
          <p:nvPr/>
        </p:nvSpPr>
        <p:spPr>
          <a:xfrm>
            <a:off x="4798544" y="1521550"/>
            <a:ext cx="2672756" cy="154554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NO" sz="1400"/>
              <a:t>Indication</a:t>
            </a:r>
          </a:p>
          <a:p>
            <a:pPr>
              <a:lnSpc>
                <a:spcPct val="100000"/>
              </a:lnSpc>
            </a:pPr>
            <a:r>
              <a:rPr lang="en-NO" sz="1400"/>
              <a:t>Medication</a:t>
            </a:r>
          </a:p>
          <a:p>
            <a:pPr>
              <a:lnSpc>
                <a:spcPct val="100000"/>
              </a:lnSpc>
            </a:pPr>
            <a:r>
              <a:rPr lang="en-NO" sz="1400"/>
              <a:t>Dose - Concentration - Volume</a:t>
            </a:r>
          </a:p>
          <a:p>
            <a:pPr>
              <a:lnSpc>
                <a:spcPct val="100000"/>
              </a:lnSpc>
            </a:pPr>
            <a:r>
              <a:rPr lang="en-NO" sz="1400"/>
              <a:t>Route</a:t>
            </a:r>
          </a:p>
          <a:p>
            <a:pPr>
              <a:lnSpc>
                <a:spcPct val="100000"/>
              </a:lnSpc>
            </a:pPr>
            <a:r>
              <a:rPr lang="en-NO" sz="1400"/>
              <a:t>Contraindications</a:t>
            </a:r>
          </a:p>
        </p:txBody>
      </p:sp>
      <p:sp>
        <p:nvSpPr>
          <p:cNvPr id="11" name="Subtitle 2">
            <a:extLst>
              <a:ext uri="{FF2B5EF4-FFF2-40B4-BE49-F238E27FC236}">
                <a16:creationId xmlns:a16="http://schemas.microsoft.com/office/drawing/2014/main" id="{B5C39A11-F470-0967-39C7-D906D9E34A05}"/>
              </a:ext>
            </a:extLst>
          </p:cNvPr>
          <p:cNvSpPr txBox="1">
            <a:spLocks/>
          </p:cNvSpPr>
          <p:nvPr/>
        </p:nvSpPr>
        <p:spPr>
          <a:xfrm>
            <a:off x="5268759" y="3958777"/>
            <a:ext cx="1517324" cy="113769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1400"/>
              <a:t>Confirms and asks back if any of the above mentioned points are missing</a:t>
            </a:r>
          </a:p>
        </p:txBody>
      </p:sp>
      <p:sp>
        <p:nvSpPr>
          <p:cNvPr id="14" name="Subtitle 2">
            <a:extLst>
              <a:ext uri="{FF2B5EF4-FFF2-40B4-BE49-F238E27FC236}">
                <a16:creationId xmlns:a16="http://schemas.microsoft.com/office/drawing/2014/main" id="{46B428CD-8B7E-EE5D-5FCC-973304B87D2B}"/>
              </a:ext>
            </a:extLst>
          </p:cNvPr>
          <p:cNvSpPr txBox="1">
            <a:spLocks/>
          </p:cNvSpPr>
          <p:nvPr/>
        </p:nvSpPr>
        <p:spPr>
          <a:xfrm>
            <a:off x="7091836" y="1629737"/>
            <a:ext cx="1660977" cy="168400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1400" i="1"/>
              <a:t>“She is in so much pain that I´m going to give morphine, 6mg. The concentration is 1mg/mL so that will be 6mL intravenously”</a:t>
            </a:r>
          </a:p>
        </p:txBody>
      </p:sp>
      <p:sp>
        <p:nvSpPr>
          <p:cNvPr id="15" name="Subtitle 2">
            <a:extLst>
              <a:ext uri="{FF2B5EF4-FFF2-40B4-BE49-F238E27FC236}">
                <a16:creationId xmlns:a16="http://schemas.microsoft.com/office/drawing/2014/main" id="{7CE3879D-4E3F-8B68-30A3-D6CEFC061A9D}"/>
              </a:ext>
            </a:extLst>
          </p:cNvPr>
          <p:cNvSpPr txBox="1">
            <a:spLocks/>
          </p:cNvSpPr>
          <p:nvPr/>
        </p:nvSpPr>
        <p:spPr>
          <a:xfrm>
            <a:off x="6854997" y="4036710"/>
            <a:ext cx="1945967" cy="82878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1400" i="1"/>
              <a:t>“6mg of morphine. Sound</a:t>
            </a:r>
            <a:r>
              <a:rPr lang="nb-NO" sz="1400" i="1"/>
              <a:t>s</a:t>
            </a:r>
            <a:r>
              <a:rPr lang="en-NO" sz="1400" i="1"/>
              <a:t> reasonable. Are there any contrainications?”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394B342C-6F13-ED8C-DFE0-E8804CE3CD74}"/>
              </a:ext>
            </a:extLst>
          </p:cNvPr>
          <p:cNvSpPr txBox="1">
            <a:spLocks/>
          </p:cNvSpPr>
          <p:nvPr/>
        </p:nvSpPr>
        <p:spPr>
          <a:xfrm>
            <a:off x="6311749" y="3399914"/>
            <a:ext cx="1259890" cy="39313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2000" b="1"/>
              <a:t>Person 2</a:t>
            </a:r>
          </a:p>
        </p:txBody>
      </p:sp>
      <p:sp>
        <p:nvSpPr>
          <p:cNvPr id="18" name="Subtitle 2">
            <a:extLst>
              <a:ext uri="{FF2B5EF4-FFF2-40B4-BE49-F238E27FC236}">
                <a16:creationId xmlns:a16="http://schemas.microsoft.com/office/drawing/2014/main" id="{B3CA0B36-1109-854D-4981-0B946997A69C}"/>
              </a:ext>
            </a:extLst>
          </p:cNvPr>
          <p:cNvSpPr txBox="1">
            <a:spLocks/>
          </p:cNvSpPr>
          <p:nvPr/>
        </p:nvSpPr>
        <p:spPr>
          <a:xfrm>
            <a:off x="5106087" y="5616187"/>
            <a:ext cx="1679996" cy="99523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1400"/>
              <a:t>Confirms or answers any questions. Performs administration. </a:t>
            </a:r>
          </a:p>
        </p:txBody>
      </p:sp>
      <p:sp>
        <p:nvSpPr>
          <p:cNvPr id="19" name="Subtitle 2">
            <a:extLst>
              <a:ext uri="{FF2B5EF4-FFF2-40B4-BE49-F238E27FC236}">
                <a16:creationId xmlns:a16="http://schemas.microsoft.com/office/drawing/2014/main" id="{B8BD278F-F00F-1AC9-91AC-AE783472F65E}"/>
              </a:ext>
            </a:extLst>
          </p:cNvPr>
          <p:cNvSpPr txBox="1">
            <a:spLocks/>
          </p:cNvSpPr>
          <p:nvPr/>
        </p:nvSpPr>
        <p:spPr>
          <a:xfrm>
            <a:off x="6996872" y="5616187"/>
            <a:ext cx="1945968" cy="90338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NO" sz="1400" i="1"/>
              <a:t>“No contraindications”</a:t>
            </a:r>
          </a:p>
          <a:p>
            <a:pPr algn="l"/>
            <a:r>
              <a:rPr lang="en-NO" sz="1400" i="1"/>
              <a:t>”I´ve given 6mg of morphine“</a:t>
            </a:r>
          </a:p>
        </p:txBody>
      </p:sp>
      <p:sp>
        <p:nvSpPr>
          <p:cNvPr id="23" name="Subtitle 2">
            <a:extLst>
              <a:ext uri="{FF2B5EF4-FFF2-40B4-BE49-F238E27FC236}">
                <a16:creationId xmlns:a16="http://schemas.microsoft.com/office/drawing/2014/main" id="{F8743BD6-698D-C92A-C994-C99848CD1D96}"/>
              </a:ext>
            </a:extLst>
          </p:cNvPr>
          <p:cNvSpPr txBox="1">
            <a:spLocks/>
          </p:cNvSpPr>
          <p:nvPr/>
        </p:nvSpPr>
        <p:spPr>
          <a:xfrm>
            <a:off x="961544" y="2399502"/>
            <a:ext cx="3019122" cy="138767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2000" b="1"/>
              <a:t>Cross-check medications</a:t>
            </a:r>
          </a:p>
          <a:p>
            <a:r>
              <a:rPr lang="en-NO" sz="1600"/>
              <a:t>Plan which medications might be needed and cross-check before transport</a:t>
            </a:r>
            <a:endParaRPr lang="en-NO" sz="1600" b="1"/>
          </a:p>
        </p:txBody>
      </p:sp>
      <p:sp>
        <p:nvSpPr>
          <p:cNvPr id="25" name="Subtitle 2">
            <a:extLst>
              <a:ext uri="{FF2B5EF4-FFF2-40B4-BE49-F238E27FC236}">
                <a16:creationId xmlns:a16="http://schemas.microsoft.com/office/drawing/2014/main" id="{7DA493CC-B5ED-A538-F71D-961DD20BE214}"/>
              </a:ext>
            </a:extLst>
          </p:cNvPr>
          <p:cNvSpPr txBox="1">
            <a:spLocks/>
          </p:cNvSpPr>
          <p:nvPr/>
        </p:nvSpPr>
        <p:spPr>
          <a:xfrm>
            <a:off x="1196396" y="5100655"/>
            <a:ext cx="2324460" cy="1162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2000" b="1"/>
              <a:t>Report</a:t>
            </a:r>
          </a:p>
          <a:p>
            <a:r>
              <a:rPr lang="en-NO" sz="1600"/>
              <a:t>Report all adverse events (and potential events)</a:t>
            </a:r>
          </a:p>
          <a:p>
            <a:endParaRPr lang="en-NO" sz="1600" b="1"/>
          </a:p>
        </p:txBody>
      </p:sp>
      <p:sp>
        <p:nvSpPr>
          <p:cNvPr id="26" name="Subtitle 2">
            <a:extLst>
              <a:ext uri="{FF2B5EF4-FFF2-40B4-BE49-F238E27FC236}">
                <a16:creationId xmlns:a16="http://schemas.microsoft.com/office/drawing/2014/main" id="{72F3C504-B40A-F1C3-0101-EEF8E2EBC3D5}"/>
              </a:ext>
            </a:extLst>
          </p:cNvPr>
          <p:cNvSpPr txBox="1">
            <a:spLocks/>
          </p:cNvSpPr>
          <p:nvPr/>
        </p:nvSpPr>
        <p:spPr>
          <a:xfrm>
            <a:off x="1226078" y="3764660"/>
            <a:ext cx="2393342" cy="12923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2000" b="1"/>
              <a:t>Label</a:t>
            </a:r>
          </a:p>
          <a:p>
            <a:r>
              <a:rPr lang="en-NO" sz="1600"/>
              <a:t>Mark all syringes with premade labels</a:t>
            </a:r>
          </a:p>
          <a:p>
            <a:endParaRPr lang="en-NO" sz="1600" b="1"/>
          </a:p>
          <a:p>
            <a:endParaRPr lang="en-NO" sz="1600" b="1"/>
          </a:p>
        </p:txBody>
      </p:sp>
      <p:sp>
        <p:nvSpPr>
          <p:cNvPr id="27" name="Subtitle 2">
            <a:extLst>
              <a:ext uri="{FF2B5EF4-FFF2-40B4-BE49-F238E27FC236}">
                <a16:creationId xmlns:a16="http://schemas.microsoft.com/office/drawing/2014/main" id="{BF135D62-A373-1D18-30CF-DA68D797E3DA}"/>
              </a:ext>
            </a:extLst>
          </p:cNvPr>
          <p:cNvSpPr txBox="1">
            <a:spLocks/>
          </p:cNvSpPr>
          <p:nvPr/>
        </p:nvSpPr>
        <p:spPr>
          <a:xfrm>
            <a:off x="1316019" y="2742230"/>
            <a:ext cx="2196798" cy="8074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NO" sz="1200"/>
          </a:p>
        </p:txBody>
      </p:sp>
      <p:sp>
        <p:nvSpPr>
          <p:cNvPr id="31" name="Subtitle 2">
            <a:extLst>
              <a:ext uri="{FF2B5EF4-FFF2-40B4-BE49-F238E27FC236}">
                <a16:creationId xmlns:a16="http://schemas.microsoft.com/office/drawing/2014/main" id="{E1C1CB71-A83D-8DE1-5A46-445048E5CA0D}"/>
              </a:ext>
            </a:extLst>
          </p:cNvPr>
          <p:cNvSpPr txBox="1">
            <a:spLocks/>
          </p:cNvSpPr>
          <p:nvPr/>
        </p:nvSpPr>
        <p:spPr>
          <a:xfrm>
            <a:off x="1316019" y="4123877"/>
            <a:ext cx="2196798" cy="8074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NO" sz="1200"/>
          </a:p>
        </p:txBody>
      </p:sp>
      <p:sp>
        <p:nvSpPr>
          <p:cNvPr id="32" name="Subtitle 2">
            <a:extLst>
              <a:ext uri="{FF2B5EF4-FFF2-40B4-BE49-F238E27FC236}">
                <a16:creationId xmlns:a16="http://schemas.microsoft.com/office/drawing/2014/main" id="{E45642B3-F73F-AADF-2D85-1A00707B962C}"/>
              </a:ext>
            </a:extLst>
          </p:cNvPr>
          <p:cNvSpPr txBox="1">
            <a:spLocks/>
          </p:cNvSpPr>
          <p:nvPr/>
        </p:nvSpPr>
        <p:spPr>
          <a:xfrm>
            <a:off x="1306141" y="5505524"/>
            <a:ext cx="2196798" cy="8074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NO" sz="1200"/>
          </a:p>
        </p:txBody>
      </p:sp>
      <p:sp>
        <p:nvSpPr>
          <p:cNvPr id="43" name="Subtitle 2">
            <a:extLst>
              <a:ext uri="{FF2B5EF4-FFF2-40B4-BE49-F238E27FC236}">
                <a16:creationId xmlns:a16="http://schemas.microsoft.com/office/drawing/2014/main" id="{A9D91AAC-DBB9-188F-B050-4FAE2ADCB469}"/>
              </a:ext>
            </a:extLst>
          </p:cNvPr>
          <p:cNvSpPr txBox="1">
            <a:spLocks/>
          </p:cNvSpPr>
          <p:nvPr/>
        </p:nvSpPr>
        <p:spPr>
          <a:xfrm>
            <a:off x="6353504" y="5044634"/>
            <a:ext cx="1259891" cy="39313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NO" sz="2000" b="1"/>
              <a:t>Person 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473BD9C-4D28-454C-7106-25552E4F5B21}"/>
              </a:ext>
            </a:extLst>
          </p:cNvPr>
          <p:cNvSpPr txBox="1"/>
          <p:nvPr/>
        </p:nvSpPr>
        <p:spPr>
          <a:xfrm>
            <a:off x="5790532" y="541607"/>
            <a:ext cx="45720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NO" sz="2000" b="1"/>
              <a:t>Example of cross-check</a:t>
            </a:r>
          </a:p>
        </p:txBody>
      </p:sp>
    </p:spTree>
    <p:extLst>
      <p:ext uri="{BB962C8B-B14F-4D97-AF65-F5344CB8AC3E}">
        <p14:creationId xmlns:p14="http://schemas.microsoft.com/office/powerpoint/2010/main" val="1789514953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14c9e8d2-9c90-447f-8175-4e24eb0c08a3" xsi:nil="true"/>
    <lcf76f155ced4ddcb4097134ff3c332f xmlns="639c7353-d616-4b28-91cc-00feb26184a9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73209E1C1306748A7290C601EA993AA" ma:contentTypeVersion="16" ma:contentTypeDescription="Create a new document." ma:contentTypeScope="" ma:versionID="b3b4d08b34f5bc5a58ecd87af2733a1b">
  <xsd:schema xmlns:xsd="http://www.w3.org/2001/XMLSchema" xmlns:xs="http://www.w3.org/2001/XMLSchema" xmlns:p="http://schemas.microsoft.com/office/2006/metadata/properties" xmlns:ns2="639c7353-d616-4b28-91cc-00feb26184a9" xmlns:ns3="14c9e8d2-9c90-447f-8175-4e24eb0c08a3" targetNamespace="http://schemas.microsoft.com/office/2006/metadata/properties" ma:root="true" ma:fieldsID="1782459a45be71a50496c122928b6556" ns2:_="" ns3:_="">
    <xsd:import namespace="639c7353-d616-4b28-91cc-00feb26184a9"/>
    <xsd:import namespace="14c9e8d2-9c90-447f-8175-4e24eb0c08a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39c7353-d616-4b28-91cc-00feb26184a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6e7bc199-5fe5-462f-a3d8-26f806c1f49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23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c9e8d2-9c90-447f-8175-4e24eb0c08a3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1135f7e3-f216-4c55-be26-a14c2b88b984}" ma:internalName="TaxCatchAll" ma:showField="CatchAllData" ma:web="14c9e8d2-9c90-447f-8175-4e24eb0c08a3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10D91E3-DD00-402B-9DD0-F78D088395D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ADF6120-9F1C-43DB-A4C2-DEE35FADDC84}">
  <ds:schemaRefs>
    <ds:schemaRef ds:uri="14c9e8d2-9c90-447f-8175-4e24eb0c08a3"/>
    <ds:schemaRef ds:uri="639c7353-d616-4b28-91cc-00feb26184a9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FD3B5203-A7E7-4AC2-BFF2-3D8CF1001ACB}">
  <ds:schemaRefs>
    <ds:schemaRef ds:uri="14c9e8d2-9c90-447f-8175-4e24eb0c08a3"/>
    <ds:schemaRef ds:uri="639c7353-d616-4b28-91cc-00feb26184a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Application>Microsoft Office PowerPoint</Application>
  <PresentationFormat>On-screen Show (4:3)</PresentationFormat>
  <Slides>1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Medication administration in the ambulance servic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kamenthåndtering i ambulansetjenesten  </dc:title>
  <dc:creator>kjetil myhr</dc:creator>
  <cp:revision>1</cp:revision>
  <dcterms:created xsi:type="dcterms:W3CDTF">2022-04-25T11:48:05Z</dcterms:created>
  <dcterms:modified xsi:type="dcterms:W3CDTF">2026-01-13T08:37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73209E1C1306748A7290C601EA993AA</vt:lpwstr>
  </property>
  <property fmtid="{D5CDD505-2E9C-101B-9397-08002B2CF9AE}" pid="3" name="MediaServiceImageTags">
    <vt:lpwstr/>
  </property>
</Properties>
</file>